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drawings/drawing1.xml" ContentType="application/vnd.openxmlformats-officedocument.drawingml.chartshap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  <p:sldId id="259" r:id="rId4"/>
    <p:sldId id="258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2628" y="-1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hD\PhD_all\PhD%20thesis\Chapter%205%20(Vib%20Trial)\Working\ROM_RFI\ROM%20IR%20v2%203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hD\PhD_all\PhD%20thesis\Chapter%205%20(Vib%20Trial)\Working\ROM_RFI\ROM%20IR%20v2%203a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H:\PhD\PhD%20-%20Working%20folder\Working\Pain\Done\Pain%20-%20How%20much%20difficulty%20do%20you%20have%20with%20activites%20above%20your%20hea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AU"/>
  <c:chart>
    <c:autoTitleDeleted val="1"/>
    <c:plotArea>
      <c:layout>
        <c:manualLayout>
          <c:layoutTarget val="inner"/>
          <c:xMode val="edge"/>
          <c:yMode val="edge"/>
          <c:x val="0.14580336832895888"/>
          <c:y val="6.9935112277631994E-2"/>
          <c:w val="0.82600907699037696"/>
          <c:h val="0.80117279090113691"/>
        </c:manualLayout>
      </c:layout>
      <c:lineChart>
        <c:grouping val="standard"/>
        <c:ser>
          <c:idx val="0"/>
          <c:order val="0"/>
          <c:tx>
            <c:strRef>
              <c:f>Sheet1!$B$4</c:f>
              <c:strCache>
                <c:ptCount val="1"/>
                <c:pt idx="0">
                  <c:v>Vibration</c:v>
                </c:pt>
              </c:strCache>
            </c:strRef>
          </c:tx>
          <c:spPr>
            <a:ln>
              <a:solidFill>
                <a:srgbClr val="0070C0"/>
              </a:solidFill>
            </a:ln>
          </c:spPr>
          <c:errBars>
            <c:errDir val="y"/>
            <c:errBarType val="both"/>
            <c:errValType val="cust"/>
            <c:plus>
              <c:numRef>
                <c:f>(Sheet1!$B$71,Sheet1!$E$71,Sheet1!$H$71,Sheet1!$K$71)</c:f>
                <c:numCache>
                  <c:formatCode>General</c:formatCode>
                  <c:ptCount val="4"/>
                  <c:pt idx="0">
                    <c:v>0.65197079180819073</c:v>
                  </c:pt>
                  <c:pt idx="1">
                    <c:v>0.59693189194062934</c:v>
                  </c:pt>
                  <c:pt idx="2">
                    <c:v>0.60746267359770445</c:v>
                  </c:pt>
                  <c:pt idx="3">
                    <c:v>0.62096266765773567</c:v>
                  </c:pt>
                </c:numCache>
              </c:numRef>
            </c:plus>
            <c:minus>
              <c:numRef>
                <c:f>(Sheet1!$B$71,Sheet1!$E$71,Sheet1!$H$71,Sheet1!$K$71)</c:f>
                <c:numCache>
                  <c:formatCode>General</c:formatCode>
                  <c:ptCount val="4"/>
                  <c:pt idx="0">
                    <c:v>0.65197079180819073</c:v>
                  </c:pt>
                  <c:pt idx="1">
                    <c:v>0.59693189194062934</c:v>
                  </c:pt>
                  <c:pt idx="2">
                    <c:v>0.60746267359770445</c:v>
                  </c:pt>
                  <c:pt idx="3">
                    <c:v>0.62096266765773567</c:v>
                  </c:pt>
                </c:numCache>
              </c:numRef>
            </c:minus>
            <c:spPr>
              <a:ln>
                <a:solidFill>
                  <a:srgbClr val="0070C0"/>
                </a:solidFill>
              </a:ln>
            </c:spPr>
          </c:errBars>
          <c:cat>
            <c:numRef>
              <c:f>(Sheet1!$B$2,Sheet1!$E$2,Sheet1!$H$2,Sheet1!$K$2)</c:f>
              <c:numCache>
                <c:formatCode>General</c:formatCode>
                <c:ptCount val="4"/>
                <c:pt idx="0">
                  <c:v>-9</c:v>
                </c:pt>
                <c:pt idx="1">
                  <c:v>6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(Sheet1!$B$69,Sheet1!$E$69,Sheet1!$H$69,Sheet1!$K$69)</c:f>
              <c:numCache>
                <c:formatCode>0.00</c:formatCode>
                <c:ptCount val="4"/>
                <c:pt idx="0">
                  <c:v>8.2333333333333254</c:v>
                </c:pt>
                <c:pt idx="1">
                  <c:v>6.1</c:v>
                </c:pt>
                <c:pt idx="2">
                  <c:v>7.3392857142857144</c:v>
                </c:pt>
                <c:pt idx="3">
                  <c:v>9.3275862068965587</c:v>
                </c:pt>
              </c:numCache>
            </c:numRef>
          </c:val>
        </c:ser>
        <c:ser>
          <c:idx val="1"/>
          <c:order val="1"/>
          <c:tx>
            <c:strRef>
              <c:f>Sheet1!$C$4</c:f>
              <c:strCache>
                <c:ptCount val="1"/>
                <c:pt idx="0">
                  <c:v>Placebo</c:v>
                </c:pt>
              </c:strCache>
            </c:strRef>
          </c:tx>
          <c:spPr>
            <a:ln>
              <a:solidFill>
                <a:srgbClr val="92D050"/>
              </a:solidFill>
              <a:prstDash val="sysDash"/>
            </a:ln>
          </c:spPr>
          <c:marker>
            <c:spPr>
              <a:solidFill>
                <a:srgbClr val="92D050"/>
              </a:solidFill>
              <a:ln>
                <a:solidFill>
                  <a:srgbClr val="92D050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(Sheet1!$C$71,Sheet1!$F$71,Sheet1!$I$71,Sheet1!$L$71)</c:f>
                <c:numCache>
                  <c:formatCode>General</c:formatCode>
                  <c:ptCount val="4"/>
                  <c:pt idx="0">
                    <c:v>0.6483370761026046</c:v>
                  </c:pt>
                  <c:pt idx="1">
                    <c:v>0.53493755905749918</c:v>
                  </c:pt>
                  <c:pt idx="2">
                    <c:v>0.56681463107069452</c:v>
                  </c:pt>
                  <c:pt idx="3">
                    <c:v>0.60156553959561798</c:v>
                  </c:pt>
                </c:numCache>
              </c:numRef>
            </c:plus>
            <c:minus>
              <c:numRef>
                <c:f>(Sheet1!$C$71,Sheet1!$F$71,Sheet1!$I$71,Sheet1!$L$71)</c:f>
                <c:numCache>
                  <c:formatCode>General</c:formatCode>
                  <c:ptCount val="4"/>
                  <c:pt idx="0">
                    <c:v>0.6483370761026046</c:v>
                  </c:pt>
                  <c:pt idx="1">
                    <c:v>0.53493755905749918</c:v>
                  </c:pt>
                  <c:pt idx="2">
                    <c:v>0.56681463107069452</c:v>
                  </c:pt>
                  <c:pt idx="3">
                    <c:v>0.60156553959561798</c:v>
                  </c:pt>
                </c:numCache>
              </c:numRef>
            </c:minus>
            <c:spPr>
              <a:ln>
                <a:solidFill>
                  <a:srgbClr val="92D050"/>
                </a:solidFill>
              </a:ln>
            </c:spPr>
          </c:errBars>
          <c:cat>
            <c:numRef>
              <c:f>(Sheet1!$B$2,Sheet1!$E$2,Sheet1!$H$2,Sheet1!$K$2)</c:f>
              <c:numCache>
                <c:formatCode>General</c:formatCode>
                <c:ptCount val="4"/>
                <c:pt idx="0">
                  <c:v>-9</c:v>
                </c:pt>
                <c:pt idx="1">
                  <c:v>6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(Sheet1!$C$69,Sheet1!$F$69,Sheet1!$I$69,Sheet1!$L$69)</c:f>
              <c:numCache>
                <c:formatCode>0.00</c:formatCode>
                <c:ptCount val="4"/>
                <c:pt idx="0">
                  <c:v>8.5762711864406693</c:v>
                </c:pt>
                <c:pt idx="1">
                  <c:v>5.5</c:v>
                </c:pt>
                <c:pt idx="2">
                  <c:v>7.8333333333333384</c:v>
                </c:pt>
                <c:pt idx="3">
                  <c:v>10.074074074074073</c:v>
                </c:pt>
              </c:numCache>
            </c:numRef>
          </c:val>
        </c:ser>
        <c:marker val="1"/>
        <c:axId val="82603392"/>
        <c:axId val="83199488"/>
      </c:lineChart>
      <c:catAx>
        <c:axId val="82603392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2000" baseline="0"/>
                </a:pPr>
                <a:r>
                  <a:rPr lang="en-AU" sz="2000" baseline="0"/>
                  <a:t>Weeks after Rotator Cuff Repair</a:t>
                </a:r>
              </a:p>
            </c:rich>
          </c:tx>
          <c:layout/>
        </c:title>
        <c:numFmt formatCode="General" sourceLinked="1"/>
        <c:majorTickMark val="none"/>
        <c:tickLblPos val="nextTo"/>
        <c:spPr>
          <a:ln w="25400">
            <a:solidFill>
              <a:prstClr val="black"/>
            </a:solidFill>
          </a:ln>
        </c:spPr>
        <c:txPr>
          <a:bodyPr/>
          <a:lstStyle/>
          <a:p>
            <a:pPr>
              <a:defRPr sz="1600"/>
            </a:pPr>
            <a:endParaRPr lang="en-US"/>
          </a:p>
        </c:txPr>
        <c:crossAx val="83199488"/>
        <c:crosses val="autoZero"/>
        <c:auto val="1"/>
        <c:lblAlgn val="ctr"/>
        <c:lblOffset val="100"/>
      </c:catAx>
      <c:valAx>
        <c:axId val="83199488"/>
        <c:scaling>
          <c:orientation val="minMax"/>
          <c:max val="15"/>
          <c:min val="1"/>
        </c:scaling>
        <c:axPos val="l"/>
        <c:title>
          <c:tx>
            <c:rich>
              <a:bodyPr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2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2000" dirty="0"/>
                  <a:t>Internal Rotation (</a:t>
                </a:r>
                <a:r>
                  <a:rPr lang="en-AU" sz="2000" dirty="0"/>
                  <a:t>Vertebrate </a:t>
                </a:r>
                <a:r>
                  <a:rPr lang="en-AU" sz="2000" dirty="0" smtClean="0"/>
                  <a:t>levels)</a:t>
                </a:r>
                <a:endParaRPr lang="en-AU" sz="2000" dirty="0"/>
              </a:p>
            </c:rich>
          </c:tx>
          <c:layout>
            <c:manualLayout>
              <c:xMode val="edge"/>
              <c:yMode val="edge"/>
              <c:x val="2.3611111111111142E-2"/>
              <c:y val="0.1905169145523479"/>
            </c:manualLayout>
          </c:layout>
        </c:title>
        <c:numFmt formatCode="0" sourceLinked="0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600"/>
            </a:pPr>
            <a:endParaRPr lang="en-US"/>
          </a:p>
        </c:txPr>
        <c:crossAx val="82603392"/>
        <c:crossesAt val="-15"/>
        <c:crossBetween val="between"/>
      </c:valAx>
    </c:plotArea>
    <c:legend>
      <c:legendPos val="r"/>
      <c:layout>
        <c:manualLayout>
          <c:xMode val="edge"/>
          <c:yMode val="edge"/>
          <c:x val="0.84542355643044664"/>
          <c:y val="0.74012102653835021"/>
          <c:w val="0.1351319991251094"/>
          <c:h val="9.3832020997375448E-2"/>
        </c:manualLayout>
      </c:layout>
      <c:txPr>
        <a:bodyPr/>
        <a:lstStyle/>
        <a:p>
          <a:pPr>
            <a:defRPr sz="1600"/>
          </a:pPr>
          <a:endParaRPr lang="en-US"/>
        </a:p>
      </c:txPr>
    </c:legend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AU"/>
  <c:chart>
    <c:autoTitleDeleted val="1"/>
    <c:plotArea>
      <c:layout>
        <c:manualLayout>
          <c:layoutTarget val="inner"/>
          <c:xMode val="edge"/>
          <c:yMode val="edge"/>
          <c:x val="0.14580336832895888"/>
          <c:y val="6.9935112277631994E-2"/>
          <c:w val="0.8260090769903774"/>
          <c:h val="0.80117279090113669"/>
        </c:manualLayout>
      </c:layout>
      <c:lineChart>
        <c:grouping val="standard"/>
        <c:ser>
          <c:idx val="0"/>
          <c:order val="0"/>
          <c:tx>
            <c:strRef>
              <c:f>Sheet1!$B$4</c:f>
              <c:strCache>
                <c:ptCount val="1"/>
                <c:pt idx="0">
                  <c:v>Vibration</c:v>
                </c:pt>
              </c:strCache>
            </c:strRef>
          </c:tx>
          <c:spPr>
            <a:ln>
              <a:solidFill>
                <a:srgbClr val="0070C0"/>
              </a:solidFill>
            </a:ln>
          </c:spPr>
          <c:errBars>
            <c:errDir val="y"/>
            <c:errBarType val="both"/>
            <c:errValType val="cust"/>
            <c:plus>
              <c:numRef>
                <c:f>(Sheet1!$B$71,Sheet1!$E$71,Sheet1!$H$71,Sheet1!$K$71)</c:f>
                <c:numCache>
                  <c:formatCode>General</c:formatCode>
                  <c:ptCount val="4"/>
                  <c:pt idx="0">
                    <c:v>0.65197079180819095</c:v>
                  </c:pt>
                  <c:pt idx="1">
                    <c:v>0.59693189194062901</c:v>
                  </c:pt>
                  <c:pt idx="2">
                    <c:v>0.60746267359770445</c:v>
                  </c:pt>
                  <c:pt idx="3">
                    <c:v>0.62096266765773567</c:v>
                  </c:pt>
                </c:numCache>
              </c:numRef>
            </c:plus>
            <c:minus>
              <c:numRef>
                <c:f>(Sheet1!$B$71,Sheet1!$E$71,Sheet1!$H$71,Sheet1!$K$71)</c:f>
                <c:numCache>
                  <c:formatCode>General</c:formatCode>
                  <c:ptCount val="4"/>
                  <c:pt idx="0">
                    <c:v>0.65197079180819095</c:v>
                  </c:pt>
                  <c:pt idx="1">
                    <c:v>0.59693189194062901</c:v>
                  </c:pt>
                  <c:pt idx="2">
                    <c:v>0.60746267359770445</c:v>
                  </c:pt>
                  <c:pt idx="3">
                    <c:v>0.62096266765773567</c:v>
                  </c:pt>
                </c:numCache>
              </c:numRef>
            </c:minus>
            <c:spPr>
              <a:ln>
                <a:solidFill>
                  <a:srgbClr val="0070C0"/>
                </a:solidFill>
              </a:ln>
            </c:spPr>
          </c:errBars>
          <c:cat>
            <c:numRef>
              <c:f>(Sheet1!$B$2,Sheet1!$E$2,Sheet1!$H$2,Sheet1!$K$2)</c:f>
              <c:numCache>
                <c:formatCode>General</c:formatCode>
                <c:ptCount val="4"/>
                <c:pt idx="0">
                  <c:v>-9</c:v>
                </c:pt>
                <c:pt idx="1">
                  <c:v>6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(Sheet1!$B$69,Sheet1!$E$69,Sheet1!$H$69,Sheet1!$K$69)</c:f>
              <c:numCache>
                <c:formatCode>0.00</c:formatCode>
                <c:ptCount val="4"/>
                <c:pt idx="0">
                  <c:v>8.2333333333333218</c:v>
                </c:pt>
                <c:pt idx="1">
                  <c:v>6.1</c:v>
                </c:pt>
                <c:pt idx="2">
                  <c:v>7.3392857142857144</c:v>
                </c:pt>
                <c:pt idx="3">
                  <c:v>9.3275862068965623</c:v>
                </c:pt>
              </c:numCache>
            </c:numRef>
          </c:val>
        </c:ser>
        <c:ser>
          <c:idx val="1"/>
          <c:order val="1"/>
          <c:tx>
            <c:strRef>
              <c:f>Sheet1!$C$4</c:f>
              <c:strCache>
                <c:ptCount val="1"/>
                <c:pt idx="0">
                  <c:v>Placebo</c:v>
                </c:pt>
              </c:strCache>
            </c:strRef>
          </c:tx>
          <c:spPr>
            <a:ln>
              <a:solidFill>
                <a:srgbClr val="92D050"/>
              </a:solidFill>
              <a:prstDash val="sysDash"/>
            </a:ln>
          </c:spPr>
          <c:errBars>
            <c:errDir val="y"/>
            <c:errBarType val="both"/>
            <c:errValType val="cust"/>
            <c:plus>
              <c:numRef>
                <c:f>(Sheet1!$C$71,Sheet1!$F$71,Sheet1!$I$71,Sheet1!$L$71)</c:f>
                <c:numCache>
                  <c:formatCode>General</c:formatCode>
                  <c:ptCount val="4"/>
                  <c:pt idx="0">
                    <c:v>0.6483370761026046</c:v>
                  </c:pt>
                  <c:pt idx="1">
                    <c:v>0.53493755905749918</c:v>
                  </c:pt>
                  <c:pt idx="2">
                    <c:v>0.56681463107069463</c:v>
                  </c:pt>
                  <c:pt idx="3">
                    <c:v>0.60156553959561798</c:v>
                  </c:pt>
                </c:numCache>
              </c:numRef>
            </c:plus>
            <c:minus>
              <c:numRef>
                <c:f>(Sheet1!$C$71,Sheet1!$F$71,Sheet1!$I$71,Sheet1!$L$71)</c:f>
                <c:numCache>
                  <c:formatCode>General</c:formatCode>
                  <c:ptCount val="4"/>
                  <c:pt idx="0">
                    <c:v>0.6483370761026046</c:v>
                  </c:pt>
                  <c:pt idx="1">
                    <c:v>0.53493755905749918</c:v>
                  </c:pt>
                  <c:pt idx="2">
                    <c:v>0.56681463107069463</c:v>
                  </c:pt>
                  <c:pt idx="3">
                    <c:v>0.60156553959561798</c:v>
                  </c:pt>
                </c:numCache>
              </c:numRef>
            </c:minus>
            <c:spPr>
              <a:ln>
                <a:solidFill>
                  <a:srgbClr val="92D050"/>
                </a:solidFill>
              </a:ln>
            </c:spPr>
          </c:errBars>
          <c:cat>
            <c:numRef>
              <c:f>(Sheet1!$B$2,Sheet1!$E$2,Sheet1!$H$2,Sheet1!$K$2)</c:f>
              <c:numCache>
                <c:formatCode>General</c:formatCode>
                <c:ptCount val="4"/>
                <c:pt idx="0">
                  <c:v>-9</c:v>
                </c:pt>
                <c:pt idx="1">
                  <c:v>6</c:v>
                </c:pt>
                <c:pt idx="2">
                  <c:v>12</c:v>
                </c:pt>
                <c:pt idx="3">
                  <c:v>24</c:v>
                </c:pt>
              </c:numCache>
            </c:numRef>
          </c:cat>
          <c:val>
            <c:numRef>
              <c:f>(Sheet1!$C$69,Sheet1!$F$69,Sheet1!$I$69,Sheet1!$L$69)</c:f>
              <c:numCache>
                <c:formatCode>0.00</c:formatCode>
                <c:ptCount val="4"/>
                <c:pt idx="0">
                  <c:v>8.5762711864406658</c:v>
                </c:pt>
                <c:pt idx="1">
                  <c:v>5.5</c:v>
                </c:pt>
                <c:pt idx="2">
                  <c:v>7.8333333333333401</c:v>
                </c:pt>
                <c:pt idx="3">
                  <c:v>10.074074074074073</c:v>
                </c:pt>
              </c:numCache>
            </c:numRef>
          </c:val>
        </c:ser>
        <c:marker val="1"/>
        <c:axId val="84873216"/>
        <c:axId val="84875904"/>
      </c:lineChart>
      <c:catAx>
        <c:axId val="84873216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2000" baseline="0"/>
                </a:pPr>
                <a:r>
                  <a:rPr lang="en-AU" sz="2000" baseline="0"/>
                  <a:t>Weeks after Rotator Cuff Repair</a:t>
                </a:r>
              </a:p>
            </c:rich>
          </c:tx>
          <c:layout/>
        </c:title>
        <c:numFmt formatCode="General" sourceLinked="1"/>
        <c:majorTickMark val="none"/>
        <c:tickLblPos val="nextTo"/>
        <c:spPr>
          <a:ln w="25400">
            <a:solidFill>
              <a:prstClr val="black"/>
            </a:solidFill>
          </a:ln>
        </c:spPr>
        <c:txPr>
          <a:bodyPr/>
          <a:lstStyle/>
          <a:p>
            <a:pPr>
              <a:defRPr sz="1600"/>
            </a:pPr>
            <a:endParaRPr lang="en-US"/>
          </a:p>
        </c:txPr>
        <c:crossAx val="84875904"/>
        <c:crosses val="autoZero"/>
        <c:auto val="1"/>
        <c:lblAlgn val="ctr"/>
        <c:lblOffset val="100"/>
      </c:catAx>
      <c:valAx>
        <c:axId val="84875904"/>
        <c:scaling>
          <c:orientation val="minMax"/>
          <c:max val="15"/>
          <c:min val="1"/>
        </c:scaling>
        <c:axPos val="l"/>
        <c:title>
          <c:tx>
            <c:rich>
              <a:bodyPr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2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2000" dirty="0"/>
                  <a:t>Internal Rotation (</a:t>
                </a:r>
                <a:r>
                  <a:rPr lang="en-AU" sz="2000" dirty="0"/>
                  <a:t>Vertebrate </a:t>
                </a:r>
                <a:r>
                  <a:rPr lang="en-AU" sz="2000" dirty="0" smtClean="0"/>
                  <a:t>levels)</a:t>
                </a:r>
                <a:endParaRPr lang="en-AU" sz="2000" dirty="0"/>
              </a:p>
            </c:rich>
          </c:tx>
          <c:layout>
            <c:manualLayout>
              <c:xMode val="edge"/>
              <c:yMode val="edge"/>
              <c:x val="2.3611111111111149E-2"/>
              <c:y val="0.19051691455234795"/>
            </c:manualLayout>
          </c:layout>
        </c:title>
        <c:numFmt formatCode="0" sourceLinked="0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600"/>
            </a:pPr>
            <a:endParaRPr lang="en-US"/>
          </a:p>
        </c:txPr>
        <c:crossAx val="84873216"/>
        <c:crossesAt val="-15"/>
        <c:crossBetween val="between"/>
      </c:valAx>
    </c:plotArea>
    <c:legend>
      <c:legendPos val="r"/>
      <c:layout>
        <c:manualLayout>
          <c:xMode val="edge"/>
          <c:yMode val="edge"/>
          <c:x val="0.84542355643044664"/>
          <c:y val="0.74012102653835066"/>
          <c:w val="0.1351319991251094"/>
          <c:h val="9.3832020997375476E-2"/>
        </c:manualLayout>
      </c:layout>
      <c:txPr>
        <a:bodyPr/>
        <a:lstStyle/>
        <a:p>
          <a:pPr>
            <a:defRPr sz="1600"/>
          </a:pPr>
          <a:endParaRPr lang="en-US"/>
        </a:p>
      </c:txPr>
    </c:legend>
    <c:plotVisOnly val="1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AU"/>
  <c:chart>
    <c:autoTitleDeleted val="1"/>
    <c:plotArea>
      <c:layout>
        <c:manualLayout>
          <c:layoutTarget val="inner"/>
          <c:xMode val="edge"/>
          <c:yMode val="edge"/>
          <c:x val="0.21927756020740621"/>
          <c:y val="0.13206882473024206"/>
          <c:w val="0.70073852498521849"/>
          <c:h val="0.67244065325167834"/>
        </c:manualLayout>
      </c:layout>
      <c:lineChart>
        <c:grouping val="standard"/>
        <c:ser>
          <c:idx val="0"/>
          <c:order val="0"/>
          <c:tx>
            <c:strRef>
              <c:f>Sheet1!$S$4</c:f>
              <c:strCache>
                <c:ptCount val="1"/>
                <c:pt idx="0">
                  <c:v>Vibration</c:v>
                </c:pt>
              </c:strCache>
            </c:strRef>
          </c:tx>
          <c:spPr>
            <a:ln>
              <a:solidFill>
                <a:srgbClr val="0070C0"/>
              </a:solidFill>
              <a:prstDash val="solid"/>
            </a:ln>
          </c:spPr>
          <c:errBars>
            <c:errDir val="y"/>
            <c:errBarType val="both"/>
            <c:errValType val="cust"/>
            <c:pl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0.12908209629527556</c:v>
                  </c:pt>
                  <c:pt idx="1">
                    <c:v>0.16207722149701626</c:v>
                  </c:pt>
                  <c:pt idx="2">
                    <c:v>0.18538488297990471</c:v>
                  </c:pt>
                  <c:pt idx="3">
                    <c:v>0.16524355544590541</c:v>
                  </c:pt>
                  <c:pt idx="4">
                    <c:v>0.14292949787065537</c:v>
                  </c:pt>
                </c:numCache>
              </c:numRef>
            </c:plus>
            <c:min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0.12908209629527556</c:v>
                  </c:pt>
                  <c:pt idx="1">
                    <c:v>0.16207722149701626</c:v>
                  </c:pt>
                  <c:pt idx="2">
                    <c:v>0.18538488297990471</c:v>
                  </c:pt>
                  <c:pt idx="3">
                    <c:v>0.16524355544590541</c:v>
                  </c:pt>
                  <c:pt idx="4">
                    <c:v>0.14292949787065537</c:v>
                  </c:pt>
                </c:numCache>
              </c:numRef>
            </c:minus>
          </c:errBars>
          <c:cat>
            <c:numRef>
              <c:f>(Sheet1!$S$2,Sheet1!$V$2,Sheet1!$Y$2,Sheet1!$AB$2,Sheet1!$AE$2)</c:f>
              <c:numCache>
                <c:formatCode>General</c:formatCode>
                <c:ptCount val="5"/>
                <c:pt idx="0">
                  <c:v>-1</c:v>
                </c:pt>
                <c:pt idx="1">
                  <c:v>1</c:v>
                </c:pt>
                <c:pt idx="2">
                  <c:v>6</c:v>
                </c:pt>
                <c:pt idx="3">
                  <c:v>12</c:v>
                </c:pt>
                <c:pt idx="4">
                  <c:v>24</c:v>
                </c:pt>
              </c:numCache>
            </c:numRef>
          </c:cat>
          <c:val>
            <c:numRef>
              <c:f>(Sheet1!$S$69,Sheet1!$V$69,Sheet1!$Y$69,Sheet1!$AB$69,Sheet1!$AE$69)</c:f>
              <c:numCache>
                <c:formatCode>0.00</c:formatCode>
                <c:ptCount val="5"/>
                <c:pt idx="0">
                  <c:v>3.0163934426229542</c:v>
                </c:pt>
                <c:pt idx="1">
                  <c:v>3.6744186046511627</c:v>
                </c:pt>
                <c:pt idx="2">
                  <c:v>2.7924528301886755</c:v>
                </c:pt>
                <c:pt idx="3">
                  <c:v>2.1851851851851847</c:v>
                </c:pt>
                <c:pt idx="4">
                  <c:v>1.7358490566037739</c:v>
                </c:pt>
              </c:numCache>
            </c:numRef>
          </c:val>
        </c:ser>
        <c:ser>
          <c:idx val="1"/>
          <c:order val="1"/>
          <c:tx>
            <c:strRef>
              <c:f>Sheet1!$T$4</c:f>
              <c:strCache>
                <c:ptCount val="1"/>
                <c:pt idx="0">
                  <c:v>Placebo</c:v>
                </c:pt>
              </c:strCache>
            </c:strRef>
          </c:tx>
          <c:spPr>
            <a:ln>
              <a:solidFill>
                <a:srgbClr val="92D050"/>
              </a:solidFill>
              <a:prstDash val="sysDash"/>
            </a:ln>
          </c:spPr>
          <c:marker>
            <c:spPr>
              <a:solidFill>
                <a:srgbClr val="92D050"/>
              </a:solidFill>
              <a:ln>
                <a:solidFill>
                  <a:srgbClr val="92D050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4843897105039308</c:v>
                  </c:pt>
                  <c:pt idx="1">
                    <c:v>0.13913064518828042</c:v>
                  </c:pt>
                  <c:pt idx="2">
                    <c:v>0.14562279831062711</c:v>
                  </c:pt>
                  <c:pt idx="3">
                    <c:v>0.14509803921568626</c:v>
                  </c:pt>
                  <c:pt idx="4">
                    <c:v>0.16526515690749427</c:v>
                  </c:pt>
                </c:numCache>
              </c:numRef>
            </c:plus>
            <c:min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4843897105039308</c:v>
                  </c:pt>
                  <c:pt idx="1">
                    <c:v>0.13913064518828042</c:v>
                  </c:pt>
                  <c:pt idx="2">
                    <c:v>0.14562279831062711</c:v>
                  </c:pt>
                  <c:pt idx="3">
                    <c:v>0.14509803921568626</c:v>
                  </c:pt>
                  <c:pt idx="4">
                    <c:v>0.16526515690749427</c:v>
                  </c:pt>
                </c:numCache>
              </c:numRef>
            </c:minus>
          </c:errBars>
          <c:val>
            <c:numRef>
              <c:f>(Sheet1!$T$69,Sheet1!$W$69,Sheet1!$Z$69,Sheet1!$AC$69,Sheet1!$AF$69)</c:f>
              <c:numCache>
                <c:formatCode>0.00</c:formatCode>
                <c:ptCount val="5"/>
                <c:pt idx="0">
                  <c:v>3.0517241379310351</c:v>
                </c:pt>
                <c:pt idx="1">
                  <c:v>3.6666666666666665</c:v>
                </c:pt>
                <c:pt idx="2">
                  <c:v>3.0181818181818207</c:v>
                </c:pt>
                <c:pt idx="3">
                  <c:v>2.2549019607843173</c:v>
                </c:pt>
                <c:pt idx="4">
                  <c:v>1.6470588235294121</c:v>
                </c:pt>
              </c:numCache>
            </c:numRef>
          </c:val>
        </c:ser>
        <c:marker val="1"/>
        <c:axId val="85532032"/>
        <c:axId val="85403136"/>
      </c:lineChart>
      <c:catAx>
        <c:axId val="85532032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2400" baseline="0"/>
                </a:pPr>
                <a:r>
                  <a:rPr lang="en-US" sz="2400" baseline="0"/>
                  <a:t>Weeks after Rotator Cuff Repair</a:t>
                </a:r>
              </a:p>
            </c:rich>
          </c:tx>
          <c:layout>
            <c:manualLayout>
              <c:xMode val="edge"/>
              <c:yMode val="edge"/>
              <c:x val="0.29674988147150066"/>
              <c:y val="0.89024992709244699"/>
            </c:manualLayout>
          </c:layout>
        </c:title>
        <c:numFmt formatCode="General" sourceLinked="1"/>
        <c:majorTickMark val="none"/>
        <c:tickLblPos val="nextTo"/>
        <c:txPr>
          <a:bodyPr/>
          <a:lstStyle/>
          <a:p>
            <a:pPr>
              <a:defRPr sz="1600" baseline="0"/>
            </a:pPr>
            <a:endParaRPr lang="en-US"/>
          </a:p>
        </c:txPr>
        <c:crossAx val="85403136"/>
        <c:crosses val="autoZero"/>
        <c:auto val="1"/>
        <c:lblAlgn val="ctr"/>
        <c:lblOffset val="100"/>
      </c:catAx>
      <c:valAx>
        <c:axId val="85403136"/>
        <c:scaling>
          <c:orientation val="minMax"/>
          <c:max val="4"/>
        </c:scaling>
        <c:axPos val="l"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24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AU" sz="2400" b="1" i="0" baseline="0" dirty="0"/>
                  <a:t>Difficulty with Overhead </a:t>
                </a:r>
                <a:r>
                  <a:rPr lang="en-AU" sz="2400" b="1" i="0" baseline="0" dirty="0" smtClean="0"/>
                  <a:t>Activities</a:t>
                </a:r>
                <a:endParaRPr lang="en-AU" sz="2400" baseline="0" dirty="0"/>
              </a:p>
            </c:rich>
          </c:tx>
          <c:layout>
            <c:manualLayout>
              <c:xMode val="edge"/>
              <c:yMode val="edge"/>
              <c:x val="3.1838494544635172E-2"/>
              <c:y val="0.16263371245261016"/>
            </c:manualLayout>
          </c:layout>
        </c:title>
        <c:numFmt formatCode="0.00" sourceLinked="1"/>
        <c:tickLblPos val="nextTo"/>
        <c:crossAx val="85532032"/>
        <c:crosses val="autoZero"/>
        <c:crossBetween val="between"/>
        <c:majorUnit val="1"/>
      </c:valAx>
    </c:plotArea>
    <c:legend>
      <c:legendPos val="r"/>
      <c:layout>
        <c:manualLayout>
          <c:xMode val="edge"/>
          <c:yMode val="edge"/>
          <c:x val="0.84722480801764177"/>
          <c:y val="0.13271361913094198"/>
          <c:w val="0.13476823983733363"/>
          <c:h val="9.3832020997375462E-2"/>
        </c:manualLayout>
      </c:layout>
      <c:txPr>
        <a:bodyPr/>
        <a:lstStyle/>
        <a:p>
          <a:pPr>
            <a:defRPr sz="1600" baseline="0"/>
          </a:pPr>
          <a:endParaRPr lang="en-US"/>
        </a:p>
      </c:txPr>
    </c:legend>
    <c:plotVisOnly val="1"/>
  </c:chart>
  <c:externalData r:id="rId1"/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851</cdr:x>
      <cdr:y>0.05901</cdr:y>
    </cdr:from>
    <cdr:to>
      <cdr:x>0.22248</cdr:x>
      <cdr:y>0.85691</cdr:y>
    </cdr:to>
    <cdr:grpSp>
      <cdr:nvGrpSpPr>
        <cdr:cNvPr id="9" name="Group 8"/>
        <cdr:cNvGrpSpPr/>
      </cdr:nvGrpSpPr>
      <cdr:grpSpPr>
        <a:xfrm xmlns:a="http://schemas.openxmlformats.org/drawingml/2006/main">
          <a:off x="780255" y="404691"/>
          <a:ext cx="1259593" cy="5471998"/>
          <a:chOff x="5508104" y="980728"/>
          <a:chExt cx="1259632" cy="5400600"/>
        </a:xfrm>
      </cdr:grpSpPr>
      <cdr:sp macro="" textlink="">
        <cdr:nvSpPr>
          <cdr:cNvPr id="10" name="Rectangle 9"/>
          <cdr:cNvSpPr/>
        </cdr:nvSpPr>
        <cdr:spPr>
          <a:xfrm xmlns:a="http://schemas.openxmlformats.org/drawingml/2006/main">
            <a:off x="5508104" y="980728"/>
            <a:ext cx="1112447" cy="5400600"/>
          </a:xfrm>
          <a:prstGeom xmlns:a="http://schemas.openxmlformats.org/drawingml/2006/main" prst="rect">
            <a:avLst/>
          </a:prstGeom>
          <a:solidFill xmlns:a="http://schemas.openxmlformats.org/drawingml/2006/main">
            <a:sysClr val="window" lastClr="FFFFFF"/>
          </a:solidFill>
          <a:ln xmlns:a="http://schemas.openxmlformats.org/drawingml/2006/main" w="25400" cap="flat" cmpd="sng" algn="ctr">
            <a:solidFill>
              <a:sysClr val="window" lastClr="FFFFFF"/>
            </a:solidFill>
            <a:prstDash val="solid"/>
          </a:ln>
          <a:effectLst xmlns:a="http://schemas.openxmlformats.org/drawingml/2006/main"/>
        </cdr:spPr>
        <cdr:style>
          <a:lnRef xmlns:a="http://schemas.openxmlformats.org/drawingml/2006/main" idx="2">
            <a:schemeClr val="accent1">
              <a:shade val="50000"/>
            </a:schemeClr>
          </a:lnRef>
          <a:fillRef xmlns:a="http://schemas.openxmlformats.org/drawingml/2006/main" idx="1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lt1"/>
          </a:fontRef>
        </cdr:style>
        <cdr:txBody>
          <a:bodyPr xmlns:a="http://schemas.openxmlformats.org/drawingml/2006/main"/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9pPr>
          </a:lstStyle>
          <a:p xmlns:a="http://schemas.openxmlformats.org/drawingml/2006/main">
            <a:endParaRPr lang="en-US"/>
          </a:p>
        </cdr:txBody>
      </cdr:sp>
      <cdr:sp macro="" textlink="">
        <cdr:nvSpPr>
          <cdr:cNvPr id="11" name="TextBox 2"/>
          <cdr:cNvSpPr txBox="1"/>
        </cdr:nvSpPr>
        <cdr:spPr>
          <a:xfrm xmlns:a="http://schemas.openxmlformats.org/drawingml/2006/main">
            <a:off x="5580112" y="1268760"/>
            <a:ext cx="1150756" cy="338554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n-AU" sz="1600" dirty="0" smtClean="0"/>
              <a:t>Very severe</a:t>
            </a:r>
            <a:endParaRPr lang="en-AU" sz="1600" dirty="0"/>
          </a:p>
        </cdr:txBody>
      </cdr:sp>
      <cdr:sp macro="" textlink="">
        <cdr:nvSpPr>
          <cdr:cNvPr id="12" name="TextBox 3"/>
          <cdr:cNvSpPr txBox="1"/>
        </cdr:nvSpPr>
        <cdr:spPr>
          <a:xfrm xmlns:a="http://schemas.openxmlformats.org/drawingml/2006/main">
            <a:off x="5902721" y="2492896"/>
            <a:ext cx="744303" cy="338554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n-AU" sz="1600" dirty="0"/>
              <a:t>S</a:t>
            </a:r>
            <a:r>
              <a:rPr lang="en-AU" sz="1600" dirty="0" smtClean="0"/>
              <a:t>evere</a:t>
            </a:r>
            <a:endParaRPr lang="en-AU" sz="1600" dirty="0"/>
          </a:p>
        </cdr:txBody>
      </cdr:sp>
      <cdr:sp macro="" textlink="">
        <cdr:nvSpPr>
          <cdr:cNvPr id="13" name="TextBox 4"/>
          <cdr:cNvSpPr txBox="1"/>
        </cdr:nvSpPr>
        <cdr:spPr>
          <a:xfrm xmlns:a="http://schemas.openxmlformats.org/drawingml/2006/main">
            <a:off x="5759114" y="3573016"/>
            <a:ext cx="1008622" cy="338554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n-AU" sz="1600" dirty="0" smtClean="0"/>
              <a:t>Moderate</a:t>
            </a:r>
            <a:endParaRPr lang="en-AU" sz="1600" dirty="0"/>
          </a:p>
        </cdr:txBody>
      </cdr:sp>
      <cdr:sp macro="" textlink="">
        <cdr:nvSpPr>
          <cdr:cNvPr id="14" name="TextBox 6"/>
          <cdr:cNvSpPr txBox="1"/>
        </cdr:nvSpPr>
        <cdr:spPr>
          <a:xfrm xmlns:a="http://schemas.openxmlformats.org/drawingml/2006/main">
            <a:off x="6118131" y="4725144"/>
            <a:ext cx="558179" cy="338554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n-AU" sz="1600" dirty="0" smtClean="0"/>
              <a:t>Mild</a:t>
            </a:r>
            <a:endParaRPr lang="en-AU" sz="1600" dirty="0"/>
          </a:p>
        </cdr:txBody>
      </cdr:sp>
      <cdr:sp macro="" textlink="">
        <cdr:nvSpPr>
          <cdr:cNvPr id="15" name="TextBox 7"/>
          <cdr:cNvSpPr txBox="1"/>
        </cdr:nvSpPr>
        <cdr:spPr>
          <a:xfrm xmlns:a="http://schemas.openxmlformats.org/drawingml/2006/main">
            <a:off x="6046328" y="5805264"/>
            <a:ext cx="634904" cy="338554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n-AU" sz="1600" dirty="0" smtClean="0"/>
              <a:t>None</a:t>
            </a:r>
            <a:endParaRPr lang="en-AU" sz="1600" dirty="0"/>
          </a:p>
        </cdr:txBody>
      </cdr:sp>
    </cdr:grp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/>
          <p:nvPr/>
        </p:nvGraphicFramePr>
        <p:xfrm>
          <a:off x="1" y="0"/>
          <a:ext cx="9144000" cy="685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4" name="Group 13"/>
          <p:cNvGrpSpPr/>
          <p:nvPr/>
        </p:nvGrpSpPr>
        <p:grpSpPr>
          <a:xfrm>
            <a:off x="651241" y="44624"/>
            <a:ext cx="608391" cy="6408712"/>
            <a:chOff x="-2412776" y="44624"/>
            <a:chExt cx="608391" cy="6408712"/>
          </a:xfrm>
        </p:grpSpPr>
        <p:grpSp>
          <p:nvGrpSpPr>
            <p:cNvPr id="4" name="Group 3"/>
            <p:cNvGrpSpPr/>
            <p:nvPr/>
          </p:nvGrpSpPr>
          <p:grpSpPr>
            <a:xfrm>
              <a:off x="-2412776" y="44624"/>
              <a:ext cx="608391" cy="6408712"/>
              <a:chOff x="1835696" y="908720"/>
              <a:chExt cx="608391" cy="5400600"/>
            </a:xfrm>
          </p:grpSpPr>
          <p:sp>
            <p:nvSpPr>
              <p:cNvPr id="5" name="Rectangle 4"/>
              <p:cNvSpPr/>
              <p:nvPr/>
            </p:nvSpPr>
            <p:spPr>
              <a:xfrm>
                <a:off x="1835696" y="908720"/>
                <a:ext cx="608391" cy="54006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1979712" y="1151444"/>
                <a:ext cx="388248" cy="2852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600" dirty="0" smtClean="0"/>
                  <a:t>T7</a:t>
                </a:r>
                <a:endParaRPr lang="en-AU" sz="1600" dirty="0"/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1907704" y="2425742"/>
                <a:ext cx="492443" cy="2852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600" dirty="0" smtClean="0"/>
                  <a:t>T11</a:t>
                </a:r>
                <a:endParaRPr lang="en-AU" sz="1600" dirty="0"/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1979712" y="3760722"/>
                <a:ext cx="375424" cy="2852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600" dirty="0" smtClean="0"/>
                  <a:t>L3</a:t>
                </a:r>
                <a:endParaRPr lang="en-AU" sz="1600" dirty="0"/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2012039" y="4428212"/>
                <a:ext cx="432048" cy="2852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600" dirty="0" smtClean="0"/>
                  <a:t>L5</a:t>
                </a:r>
                <a:endParaRPr lang="en-AU" sz="1600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1979712" y="5763192"/>
                <a:ext cx="383438" cy="2852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600" dirty="0" smtClean="0"/>
                  <a:t>S4</a:t>
                </a:r>
                <a:endParaRPr lang="en-AU" sz="1600" dirty="0"/>
              </a:p>
            </p:txBody>
          </p:sp>
        </p:grpSp>
        <p:sp>
          <p:nvSpPr>
            <p:cNvPr id="11" name="TextBox 10"/>
            <p:cNvSpPr txBox="1"/>
            <p:nvPr/>
          </p:nvSpPr>
          <p:spPr>
            <a:xfrm>
              <a:off x="-2268760" y="1052736"/>
              <a:ext cx="38824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T9</a:t>
              </a:r>
              <a:endParaRPr lang="en-AU" sz="16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-2268760" y="2636912"/>
              <a:ext cx="37542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L1</a:t>
              </a:r>
              <a:endParaRPr lang="en-AU" sz="16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-2236433" y="5013176"/>
              <a:ext cx="3834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S2</a:t>
              </a:r>
              <a:endParaRPr lang="en-AU" sz="1600" dirty="0"/>
            </a:p>
          </p:txBody>
        </p:sp>
      </p:grpSp>
      <p:sp>
        <p:nvSpPr>
          <p:cNvPr id="15" name="TextBox 14"/>
          <p:cNvSpPr txBox="1"/>
          <p:nvPr/>
        </p:nvSpPr>
        <p:spPr>
          <a:xfrm>
            <a:off x="1931120" y="6093296"/>
            <a:ext cx="76867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600" dirty="0" smtClean="0"/>
              <a:t>Pre-Op</a:t>
            </a:r>
            <a:endParaRPr lang="en-AU" sz="1600" dirty="0"/>
          </a:p>
        </p:txBody>
      </p:sp>
      <p:grpSp>
        <p:nvGrpSpPr>
          <p:cNvPr id="16" name="Group 15"/>
          <p:cNvGrpSpPr/>
          <p:nvPr/>
        </p:nvGrpSpPr>
        <p:grpSpPr>
          <a:xfrm>
            <a:off x="2267744" y="2276301"/>
            <a:ext cx="1872208" cy="144016"/>
            <a:chOff x="3707904" y="3068960"/>
            <a:chExt cx="2736304" cy="144016"/>
          </a:xfrm>
        </p:grpSpPr>
        <p:cxnSp>
          <p:nvCxnSpPr>
            <p:cNvPr id="28" name="Straight Connector 27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" name="Group 16"/>
          <p:cNvGrpSpPr/>
          <p:nvPr/>
        </p:nvGrpSpPr>
        <p:grpSpPr>
          <a:xfrm>
            <a:off x="4139952" y="2708920"/>
            <a:ext cx="1872208" cy="144016"/>
            <a:chOff x="3707904" y="3068960"/>
            <a:chExt cx="2736304" cy="144016"/>
          </a:xfrm>
        </p:grpSpPr>
        <p:cxnSp>
          <p:nvCxnSpPr>
            <p:cNvPr id="25" name="Straight Connector 24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Group 17"/>
          <p:cNvGrpSpPr/>
          <p:nvPr/>
        </p:nvGrpSpPr>
        <p:grpSpPr>
          <a:xfrm>
            <a:off x="6012160" y="1916832"/>
            <a:ext cx="1944216" cy="144016"/>
            <a:chOff x="3707904" y="3068960"/>
            <a:chExt cx="2736304" cy="144016"/>
          </a:xfrm>
        </p:grpSpPr>
        <p:cxnSp>
          <p:nvCxnSpPr>
            <p:cNvPr id="22" name="Straight Connector 21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" name="TextBox 28"/>
          <p:cNvSpPr txBox="1"/>
          <p:nvPr/>
        </p:nvSpPr>
        <p:spPr>
          <a:xfrm>
            <a:off x="4789765" y="2492896"/>
            <a:ext cx="6463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AU" dirty="0" smtClean="0"/>
              <a:t>****</a:t>
            </a:r>
            <a:endParaRPr lang="en-AU" dirty="0"/>
          </a:p>
        </p:txBody>
      </p:sp>
      <p:sp>
        <p:nvSpPr>
          <p:cNvPr id="20" name="TextBox 29"/>
          <p:cNvSpPr txBox="1"/>
          <p:nvPr/>
        </p:nvSpPr>
        <p:spPr>
          <a:xfrm>
            <a:off x="6660232" y="1691516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AU" dirty="0" smtClean="0"/>
              <a:t>****</a:t>
            </a:r>
            <a:endParaRPr lang="en-AU" dirty="0"/>
          </a:p>
        </p:txBody>
      </p:sp>
      <p:sp>
        <p:nvSpPr>
          <p:cNvPr id="21" name="TextBox 32"/>
          <p:cNvSpPr txBox="1"/>
          <p:nvPr/>
        </p:nvSpPr>
        <p:spPr>
          <a:xfrm>
            <a:off x="2915816" y="2051556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AU" dirty="0" smtClean="0"/>
              <a:t>****</a:t>
            </a:r>
            <a:endParaRPr lang="en-AU" dirty="0"/>
          </a:p>
        </p:txBody>
      </p:sp>
      <p:grpSp>
        <p:nvGrpSpPr>
          <p:cNvPr id="31" name="Group 30"/>
          <p:cNvGrpSpPr/>
          <p:nvPr/>
        </p:nvGrpSpPr>
        <p:grpSpPr>
          <a:xfrm>
            <a:off x="2267744" y="1340768"/>
            <a:ext cx="5616624" cy="144016"/>
            <a:chOff x="3707904" y="3068960"/>
            <a:chExt cx="2736304" cy="144016"/>
          </a:xfrm>
        </p:grpSpPr>
        <p:cxnSp>
          <p:nvCxnSpPr>
            <p:cNvPr id="32" name="Straight Connector 31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5" name="TextBox 29"/>
          <p:cNvSpPr txBox="1"/>
          <p:nvPr/>
        </p:nvSpPr>
        <p:spPr>
          <a:xfrm>
            <a:off x="4689157" y="1115452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AU" dirty="0" smtClean="0"/>
              <a:t>***</a:t>
            </a:r>
            <a:endParaRPr lang="en-AU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/>
          <p:nvPr/>
        </p:nvGraphicFramePr>
        <p:xfrm>
          <a:off x="1" y="0"/>
          <a:ext cx="9144000" cy="685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2" name="Group 13"/>
          <p:cNvGrpSpPr/>
          <p:nvPr/>
        </p:nvGrpSpPr>
        <p:grpSpPr>
          <a:xfrm>
            <a:off x="651241" y="44624"/>
            <a:ext cx="608391" cy="6408712"/>
            <a:chOff x="-2412776" y="44624"/>
            <a:chExt cx="608391" cy="6408712"/>
          </a:xfrm>
        </p:grpSpPr>
        <p:grpSp>
          <p:nvGrpSpPr>
            <p:cNvPr id="4" name="Group 3"/>
            <p:cNvGrpSpPr/>
            <p:nvPr/>
          </p:nvGrpSpPr>
          <p:grpSpPr>
            <a:xfrm>
              <a:off x="-2412776" y="44624"/>
              <a:ext cx="608391" cy="6408712"/>
              <a:chOff x="1835696" y="908720"/>
              <a:chExt cx="608391" cy="5400600"/>
            </a:xfrm>
          </p:grpSpPr>
          <p:sp>
            <p:nvSpPr>
              <p:cNvPr id="5" name="Rectangle 4"/>
              <p:cNvSpPr/>
              <p:nvPr/>
            </p:nvSpPr>
            <p:spPr>
              <a:xfrm>
                <a:off x="1835696" y="908720"/>
                <a:ext cx="608391" cy="54006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en-US"/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1979712" y="1151444"/>
                <a:ext cx="388248" cy="2852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600" dirty="0" smtClean="0"/>
                  <a:t>T7</a:t>
                </a:r>
                <a:endParaRPr lang="en-AU" sz="1600" dirty="0"/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1907704" y="2425742"/>
                <a:ext cx="492443" cy="2852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600" dirty="0" smtClean="0"/>
                  <a:t>T11</a:t>
                </a:r>
                <a:endParaRPr lang="en-AU" sz="1600" dirty="0"/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1979712" y="3760722"/>
                <a:ext cx="375424" cy="2852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600" dirty="0" smtClean="0"/>
                  <a:t>L3</a:t>
                </a:r>
                <a:endParaRPr lang="en-AU" sz="1600" dirty="0"/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2012039" y="4428212"/>
                <a:ext cx="432048" cy="2852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600" dirty="0" smtClean="0"/>
                  <a:t>L5</a:t>
                </a:r>
                <a:endParaRPr lang="en-AU" sz="1600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1979712" y="5763192"/>
                <a:ext cx="383438" cy="2852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600" dirty="0" smtClean="0"/>
                  <a:t>S4</a:t>
                </a:r>
                <a:endParaRPr lang="en-AU" sz="1600" dirty="0"/>
              </a:p>
            </p:txBody>
          </p:sp>
        </p:grpSp>
        <p:sp>
          <p:nvSpPr>
            <p:cNvPr id="11" name="TextBox 10"/>
            <p:cNvSpPr txBox="1"/>
            <p:nvPr/>
          </p:nvSpPr>
          <p:spPr>
            <a:xfrm>
              <a:off x="-2268760" y="1052736"/>
              <a:ext cx="38824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T9</a:t>
              </a:r>
              <a:endParaRPr lang="en-AU" sz="16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-2268760" y="2636912"/>
              <a:ext cx="37542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L1</a:t>
              </a:r>
              <a:endParaRPr lang="en-AU" sz="16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-2236433" y="5013176"/>
              <a:ext cx="3834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S2</a:t>
              </a:r>
              <a:endParaRPr lang="en-AU" sz="1600" dirty="0"/>
            </a:p>
          </p:txBody>
        </p:sp>
      </p:grpSp>
      <p:sp>
        <p:nvSpPr>
          <p:cNvPr id="15" name="TextBox 14"/>
          <p:cNvSpPr txBox="1"/>
          <p:nvPr/>
        </p:nvSpPr>
        <p:spPr>
          <a:xfrm>
            <a:off x="1931120" y="6093296"/>
            <a:ext cx="76867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600" dirty="0" smtClean="0"/>
              <a:t>Pre-Op</a:t>
            </a:r>
            <a:endParaRPr lang="en-AU" sz="1600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/>
          <p:cNvGraphicFramePr/>
          <p:nvPr/>
        </p:nvGraphicFramePr>
        <p:xfrm>
          <a:off x="-24681" y="0"/>
          <a:ext cx="9168681" cy="685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755576" y="620688"/>
            <a:ext cx="1259632" cy="5400600"/>
            <a:chOff x="1331640" y="908720"/>
            <a:chExt cx="1259632" cy="5400600"/>
          </a:xfrm>
        </p:grpSpPr>
        <p:sp>
          <p:nvSpPr>
            <p:cNvPr id="10" name="Rectangle 9"/>
            <p:cNvSpPr/>
            <p:nvPr/>
          </p:nvSpPr>
          <p:spPr>
            <a:xfrm>
              <a:off x="1331640" y="908720"/>
              <a:ext cx="1112447" cy="5400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/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1403648" y="1196752"/>
              <a:ext cx="11507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Very severe</a:t>
              </a:r>
              <a:endParaRPr lang="en-AU" sz="1600" dirty="0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1726257" y="2420888"/>
              <a:ext cx="74430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/>
                <a:t>S</a:t>
              </a:r>
              <a:r>
                <a:rPr lang="en-AU" sz="1600" dirty="0" smtClean="0"/>
                <a:t>evere</a:t>
              </a:r>
              <a:endParaRPr lang="en-AU" sz="1600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1582650" y="3501008"/>
              <a:ext cx="100862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Moderate</a:t>
              </a:r>
              <a:endParaRPr lang="en-AU" sz="1600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941667" y="4653136"/>
              <a:ext cx="55817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Mild</a:t>
              </a:r>
              <a:endParaRPr lang="en-AU" sz="16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869864" y="5733256"/>
              <a:ext cx="63490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None</a:t>
              </a:r>
              <a:endParaRPr lang="en-AU" sz="1600" dirty="0"/>
            </a:p>
          </p:txBody>
        </p:sp>
      </p:grpSp>
      <p:sp>
        <p:nvSpPr>
          <p:cNvPr id="11" name="TextBox 10"/>
          <p:cNvSpPr txBox="1"/>
          <p:nvPr/>
        </p:nvSpPr>
        <p:spPr>
          <a:xfrm>
            <a:off x="3995936" y="2708920"/>
            <a:ext cx="76867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600" dirty="0" smtClean="0"/>
              <a:t>Pre-Op</a:t>
            </a:r>
            <a:endParaRPr lang="en-AU" sz="16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60</Words>
  <Application>Microsoft Office PowerPoint</Application>
  <PresentationFormat>On-screen Show (4:3)</PresentationFormat>
  <Paragraphs>34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Slide 1</vt:lpstr>
      <vt:lpstr>Slide 2</vt:lpstr>
      <vt:lpstr>Slide 3</vt:lpstr>
      <vt:lpstr>Slide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at</dc:creator>
  <cp:lastModifiedBy>Pat</cp:lastModifiedBy>
  <cp:revision>11</cp:revision>
  <dcterms:created xsi:type="dcterms:W3CDTF">2011-11-19T23:44:44Z</dcterms:created>
  <dcterms:modified xsi:type="dcterms:W3CDTF">2012-01-17T00:28:05Z</dcterms:modified>
</cp:coreProperties>
</file>